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9" r:id="rId2"/>
    <p:sldId id="260" r:id="rId3"/>
    <p:sldId id="257" r:id="rId4"/>
    <p:sldId id="258" r:id="rId5"/>
    <p:sldId id="261" r:id="rId6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6357" autoAdjust="0"/>
  </p:normalViewPr>
  <p:slideViewPr>
    <p:cSldViewPr snapToGrid="0">
      <p:cViewPr varScale="1">
        <p:scale>
          <a:sx n="114" d="100"/>
          <a:sy n="114" d="100"/>
        </p:scale>
        <p:origin x="12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C03FDE97-5349-4633-8D74-76D4087785CE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741C5144-A0F2-4A5D-A515-54CBDCDDC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325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</a:t>
            </a:r>
            <a:r>
              <a:rPr lang="en-US" baseline="0" dirty="0"/>
              <a:t> Tables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5B862E-03D9-46B9-A930-8A93A33983B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2214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Supplementary</a:t>
            </a:r>
            <a:r>
              <a:rPr lang="en-US" baseline="0" dirty="0"/>
              <a:t> Tables 2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5B862E-03D9-46B9-A930-8A93A33983B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8624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171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732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015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701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063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55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958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349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363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772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747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C24F1-BF85-4A2A-8917-775CF4793B52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782EB3-96EE-41A8-9634-A6552BF293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375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0952545"/>
              </p:ext>
            </p:extLst>
          </p:nvPr>
        </p:nvGraphicFramePr>
        <p:xfrm>
          <a:off x="3906252" y="455479"/>
          <a:ext cx="3327400" cy="4509135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1282700">
                  <a:extLst>
                    <a:ext uri="{9D8B030D-6E8A-4147-A177-3AD203B41FA5}">
                      <a16:colId xmlns:a16="http://schemas.microsoft.com/office/drawing/2014/main" val="2153331916"/>
                    </a:ext>
                  </a:extLst>
                </a:gridCol>
                <a:gridCol w="1091532">
                  <a:extLst>
                    <a:ext uri="{9D8B030D-6E8A-4147-A177-3AD203B41FA5}">
                      <a16:colId xmlns:a16="http://schemas.microsoft.com/office/drawing/2014/main" val="3670524845"/>
                    </a:ext>
                  </a:extLst>
                </a:gridCol>
                <a:gridCol w="953168">
                  <a:extLst>
                    <a:ext uri="{9D8B030D-6E8A-4147-A177-3AD203B41FA5}">
                      <a16:colId xmlns:a16="http://schemas.microsoft.com/office/drawing/2014/main" val="304911121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41807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 HRV Ab tit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54375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79054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0134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6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00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2329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 HRV Ab tit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99381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3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9369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64346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4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 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92626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ASC numb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26531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86146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88890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1726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03384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oden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9902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0 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 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27309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09773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-0.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6029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e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3234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0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92207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498914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035005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817022" y="0"/>
            <a:ext cx="37147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 |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rrelation of HRV-specific antibody titers with VirHRV shedding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817022" y="4970729"/>
            <a:ext cx="3710167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otobiotic pigs were transplanted with human infant fecal microbiota (HIFM) at 4 days of age. Pigs were fed deficient diet (Def) and sufficient diet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All the pigs were orally vaccinated twice with AttHRV on post transplantation day (PTD) 7 and 17, challenged with virulent human rotavirus (VirHRV) on PTD24/PVD17(7)/PCD0 and euthanized on PTD31/PVD24(14)/PCD7. PVD- post 1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vaccination day; PCD- post-challenge day. Ab = antibody; SIC = small intestinal content; ASC = antibody secreting cell; NS = not significant; N/A= data not available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15832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8461110"/>
              </p:ext>
            </p:extLst>
          </p:nvPr>
        </p:nvGraphicFramePr>
        <p:xfrm>
          <a:off x="4122821" y="454442"/>
          <a:ext cx="3327400" cy="4509135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1282700">
                  <a:extLst>
                    <a:ext uri="{9D8B030D-6E8A-4147-A177-3AD203B41FA5}">
                      <a16:colId xmlns:a16="http://schemas.microsoft.com/office/drawing/2014/main" val="2153331916"/>
                    </a:ext>
                  </a:extLst>
                </a:gridCol>
                <a:gridCol w="1091532">
                  <a:extLst>
                    <a:ext uri="{9D8B030D-6E8A-4147-A177-3AD203B41FA5}">
                      <a16:colId xmlns:a16="http://schemas.microsoft.com/office/drawing/2014/main" val="3670524845"/>
                    </a:ext>
                  </a:extLst>
                </a:gridCol>
                <a:gridCol w="953168">
                  <a:extLst>
                    <a:ext uri="{9D8B030D-6E8A-4147-A177-3AD203B41FA5}">
                      <a16:colId xmlns:a16="http://schemas.microsoft.com/office/drawing/2014/main" val="304911121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41807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 HRV Ab tit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54375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79054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0134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00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2329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 HRV Ab tit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99381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9369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64346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92626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ASC numb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26531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86146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88890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1726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03384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oden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9902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27309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NS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09773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6029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e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3234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92207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498914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035005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020891" y="0"/>
            <a:ext cx="37147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 |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rrelation of HRV-specific antibody titers with diarrheal score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020892" y="4963577"/>
            <a:ext cx="3526920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otobiotic pigs were transplanted with human infant fecal microbiota (HIFM) at 4 days of age. Pigs were fed deficient diet (Def) and sufficient diet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All the pigs were orally vaccinated twice with AttHRV on post transplantation day (PTD) 7 and 17, challenged with virulent human rotavirus (VirHRV) on PTD24/PVD17(7)/PCD0 and euthanized on PTD31/PVD24(14)/PCD7. PVD- post 1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vaccination day; PCD- post-challenge day. Ab = antibody; SIC = small intestinal content; ASC = antibody secreting cell; NS = not significant; N/A= data not available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44031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5466077"/>
              </p:ext>
            </p:extLst>
          </p:nvPr>
        </p:nvGraphicFramePr>
        <p:xfrm>
          <a:off x="2462464" y="1423767"/>
          <a:ext cx="7301609" cy="204216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922421">
                  <a:extLst>
                    <a:ext uri="{9D8B030D-6E8A-4147-A177-3AD203B41FA5}">
                      <a16:colId xmlns:a16="http://schemas.microsoft.com/office/drawing/2014/main" val="3932272410"/>
                    </a:ext>
                  </a:extLst>
                </a:gridCol>
                <a:gridCol w="320040">
                  <a:extLst>
                    <a:ext uri="{9D8B030D-6E8A-4147-A177-3AD203B41FA5}">
                      <a16:colId xmlns:a16="http://schemas.microsoft.com/office/drawing/2014/main" val="2148085187"/>
                    </a:ext>
                  </a:extLst>
                </a:gridCol>
                <a:gridCol w="294610">
                  <a:extLst>
                    <a:ext uri="{9D8B030D-6E8A-4147-A177-3AD203B41FA5}">
                      <a16:colId xmlns:a16="http://schemas.microsoft.com/office/drawing/2014/main" val="3210397506"/>
                    </a:ext>
                  </a:extLst>
                </a:gridCol>
                <a:gridCol w="726705">
                  <a:extLst>
                    <a:ext uri="{9D8B030D-6E8A-4147-A177-3AD203B41FA5}">
                      <a16:colId xmlns:a16="http://schemas.microsoft.com/office/drawing/2014/main" val="1558154161"/>
                    </a:ext>
                  </a:extLst>
                </a:gridCol>
                <a:gridCol w="736525">
                  <a:extLst>
                    <a:ext uri="{9D8B030D-6E8A-4147-A177-3AD203B41FA5}">
                      <a16:colId xmlns:a16="http://schemas.microsoft.com/office/drawing/2014/main" val="1998150705"/>
                    </a:ext>
                  </a:extLst>
                </a:gridCol>
                <a:gridCol w="373173">
                  <a:extLst>
                    <a:ext uri="{9D8B030D-6E8A-4147-A177-3AD203B41FA5}">
                      <a16:colId xmlns:a16="http://schemas.microsoft.com/office/drawing/2014/main" val="1055671887"/>
                    </a:ext>
                  </a:extLst>
                </a:gridCol>
                <a:gridCol w="422275">
                  <a:extLst>
                    <a:ext uri="{9D8B030D-6E8A-4147-A177-3AD203B41FA5}">
                      <a16:colId xmlns:a16="http://schemas.microsoft.com/office/drawing/2014/main" val="2508572037"/>
                    </a:ext>
                  </a:extLst>
                </a:gridCol>
                <a:gridCol w="726705">
                  <a:extLst>
                    <a:ext uri="{9D8B030D-6E8A-4147-A177-3AD203B41FA5}">
                      <a16:colId xmlns:a16="http://schemas.microsoft.com/office/drawing/2014/main" val="1516235267"/>
                    </a:ext>
                  </a:extLst>
                </a:gridCol>
                <a:gridCol w="736525">
                  <a:extLst>
                    <a:ext uri="{9D8B030D-6E8A-4147-A177-3AD203B41FA5}">
                      <a16:colId xmlns:a16="http://schemas.microsoft.com/office/drawing/2014/main" val="2051292229"/>
                    </a:ext>
                  </a:extLst>
                </a:gridCol>
                <a:gridCol w="265149">
                  <a:extLst>
                    <a:ext uri="{9D8B030D-6E8A-4147-A177-3AD203B41FA5}">
                      <a16:colId xmlns:a16="http://schemas.microsoft.com/office/drawing/2014/main" val="3948046097"/>
                    </a:ext>
                  </a:extLst>
                </a:gridCol>
                <a:gridCol w="314251">
                  <a:extLst>
                    <a:ext uri="{9D8B030D-6E8A-4147-A177-3AD203B41FA5}">
                      <a16:colId xmlns:a16="http://schemas.microsoft.com/office/drawing/2014/main" val="754049974"/>
                    </a:ext>
                  </a:extLst>
                </a:gridCol>
                <a:gridCol w="726705">
                  <a:extLst>
                    <a:ext uri="{9D8B030D-6E8A-4147-A177-3AD203B41FA5}">
                      <a16:colId xmlns:a16="http://schemas.microsoft.com/office/drawing/2014/main" val="2189996844"/>
                    </a:ext>
                  </a:extLst>
                </a:gridCol>
                <a:gridCol w="736525">
                  <a:extLst>
                    <a:ext uri="{9D8B030D-6E8A-4147-A177-3AD203B41FA5}">
                      <a16:colId xmlns:a16="http://schemas.microsoft.com/office/drawing/2014/main" val="316822624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783912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baseline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3969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Ab tite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2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94240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75938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06743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ASC numbe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2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6318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30543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oden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134876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eum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419256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347686" y="962102"/>
            <a:ext cx="70502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 |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atio of HRV-specific antibodies titer per µg total immunoglobulins and HRV-specific antibody secreting cells per total immunoglobulin secreting cells (%) at PCD0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347686" y="3465927"/>
            <a:ext cx="734618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otobiotic pigs were transplanted with human infant fecal microbiota (HIFM) at 4 days of age. Pigs were fed deficient diet (Def) and sufficient diet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All the pigs were orally vaccinated twice with AttHRV on post transplantation day (PTD) 7 and 17, challenged with virulent human rotavirus (VirHRV) on PTD24/PVD17(7)/PCD0 and euthanized on PTD31/PVD24(14)/PCD7. PVD- post 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vaccination day; PCD- post-challenge day. Data for blood, duodenum, and ileum presented as percentage. Ab = antibody; SIC = small intestinal content; ASC = antibody secreting cell; N/A= data not available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71361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8419201"/>
              </p:ext>
            </p:extLst>
          </p:nvPr>
        </p:nvGraphicFramePr>
        <p:xfrm>
          <a:off x="1443791" y="984658"/>
          <a:ext cx="7872046" cy="1887855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938462">
                  <a:extLst>
                    <a:ext uri="{9D8B030D-6E8A-4147-A177-3AD203B41FA5}">
                      <a16:colId xmlns:a16="http://schemas.microsoft.com/office/drawing/2014/main" val="2011690679"/>
                    </a:ext>
                  </a:extLst>
                </a:gridCol>
                <a:gridCol w="261811">
                  <a:extLst>
                    <a:ext uri="{9D8B030D-6E8A-4147-A177-3AD203B41FA5}">
                      <a16:colId xmlns:a16="http://schemas.microsoft.com/office/drawing/2014/main" val="235857331"/>
                    </a:ext>
                  </a:extLst>
                </a:gridCol>
                <a:gridCol w="324397">
                  <a:extLst>
                    <a:ext uri="{9D8B030D-6E8A-4147-A177-3AD203B41FA5}">
                      <a16:colId xmlns:a16="http://schemas.microsoft.com/office/drawing/2014/main" val="2070249943"/>
                    </a:ext>
                  </a:extLst>
                </a:gridCol>
                <a:gridCol w="800180">
                  <a:extLst>
                    <a:ext uri="{9D8B030D-6E8A-4147-A177-3AD203B41FA5}">
                      <a16:colId xmlns:a16="http://schemas.microsoft.com/office/drawing/2014/main" val="81303762"/>
                    </a:ext>
                  </a:extLst>
                </a:gridCol>
                <a:gridCol w="810994">
                  <a:extLst>
                    <a:ext uri="{9D8B030D-6E8A-4147-A177-3AD203B41FA5}">
                      <a16:colId xmlns:a16="http://schemas.microsoft.com/office/drawing/2014/main" val="4198617881"/>
                    </a:ext>
                  </a:extLst>
                </a:gridCol>
                <a:gridCol w="410903">
                  <a:extLst>
                    <a:ext uri="{9D8B030D-6E8A-4147-A177-3AD203B41FA5}">
                      <a16:colId xmlns:a16="http://schemas.microsoft.com/office/drawing/2014/main" val="265258522"/>
                    </a:ext>
                  </a:extLst>
                </a:gridCol>
                <a:gridCol w="464970">
                  <a:extLst>
                    <a:ext uri="{9D8B030D-6E8A-4147-A177-3AD203B41FA5}">
                      <a16:colId xmlns:a16="http://schemas.microsoft.com/office/drawing/2014/main" val="522205639"/>
                    </a:ext>
                  </a:extLst>
                </a:gridCol>
                <a:gridCol w="800180">
                  <a:extLst>
                    <a:ext uri="{9D8B030D-6E8A-4147-A177-3AD203B41FA5}">
                      <a16:colId xmlns:a16="http://schemas.microsoft.com/office/drawing/2014/main" val="867686274"/>
                    </a:ext>
                  </a:extLst>
                </a:gridCol>
                <a:gridCol w="810994">
                  <a:extLst>
                    <a:ext uri="{9D8B030D-6E8A-4147-A177-3AD203B41FA5}">
                      <a16:colId xmlns:a16="http://schemas.microsoft.com/office/drawing/2014/main" val="349638223"/>
                    </a:ext>
                  </a:extLst>
                </a:gridCol>
                <a:gridCol w="291957">
                  <a:extLst>
                    <a:ext uri="{9D8B030D-6E8A-4147-A177-3AD203B41FA5}">
                      <a16:colId xmlns:a16="http://schemas.microsoft.com/office/drawing/2014/main" val="4183550798"/>
                    </a:ext>
                  </a:extLst>
                </a:gridCol>
                <a:gridCol w="346024">
                  <a:extLst>
                    <a:ext uri="{9D8B030D-6E8A-4147-A177-3AD203B41FA5}">
                      <a16:colId xmlns:a16="http://schemas.microsoft.com/office/drawing/2014/main" val="3420282440"/>
                    </a:ext>
                  </a:extLst>
                </a:gridCol>
                <a:gridCol w="800180">
                  <a:extLst>
                    <a:ext uri="{9D8B030D-6E8A-4147-A177-3AD203B41FA5}">
                      <a16:colId xmlns:a16="http://schemas.microsoft.com/office/drawing/2014/main" val="3046689949"/>
                    </a:ext>
                  </a:extLst>
                </a:gridCol>
                <a:gridCol w="810994">
                  <a:extLst>
                    <a:ext uri="{9D8B030D-6E8A-4147-A177-3AD203B41FA5}">
                      <a16:colId xmlns:a16="http://schemas.microsoft.com/office/drawing/2014/main" val="4266530470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42071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uf + HIF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HIF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78391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Ab tite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2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38481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54011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64060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ASC numbe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2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57859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51494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odenu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18163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eum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427041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27108" y="522993"/>
            <a:ext cx="70502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 |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atio of HRV-specific antibody titers per µg total immunoglobulins and HRV-specific antibody secreting cells per total immunoglobulin secreting cells (%) at PCD7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327107" y="2872513"/>
            <a:ext cx="798872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otobiotic pigs were transplanted with human infant fecal microbiota (HIFM) at 4 days of age. Pigs were fed deficient diet (Def) and sufficient diet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All the pigs were orally vaccinated twice with AttHRV on post transplantation day (PTD) 7 and 17, challenged with virulent human rotavirus (VirHRV) on PTD24/PVD17(7)/PCD0 and euthanized on PTD31/PVD24(14)/PCD7. PVD- post 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vaccination day; PCD- post-challenge day. Data for blood, duodenum, and ileum presented as percentage. Ab = antibody; SIC = small intestinal content; ASC = antibody secreting cell; N/A= data not available.</a:t>
            </a:r>
          </a:p>
        </p:txBody>
      </p:sp>
    </p:spTree>
    <p:extLst>
      <p:ext uri="{BB962C8B-B14F-4D97-AF65-F5344CB8AC3E}">
        <p14:creationId xmlns:p14="http://schemas.microsoft.com/office/powerpoint/2010/main" val="42538427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C45F9C6-3169-42FB-B903-7F0A313770BB}"/>
              </a:ext>
            </a:extLst>
          </p:cNvPr>
          <p:cNvSpPr txBox="1"/>
          <p:nvPr/>
        </p:nvSpPr>
        <p:spPr>
          <a:xfrm>
            <a:off x="409736" y="-117446"/>
            <a:ext cx="10318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5 |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of microbiota transplantation and diets, pre- vs. post-challenge</a:t>
            </a:r>
            <a:r>
              <a:rPr lang="en-US" dirty="0"/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FC91782-5369-4BE1-8D48-38BA884331E7}"/>
              </a:ext>
            </a:extLst>
          </p:cNvPr>
          <p:cNvSpPr/>
          <p:nvPr/>
        </p:nvSpPr>
        <p:spPr>
          <a:xfrm>
            <a:off x="521765" y="6008892"/>
            <a:ext cx="632897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 = deficient diet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sufficient diet; PCD = post challenge day; HIFM= human infant fecal microbiota; SIC = small intestinal content; Ab = antibody; ASCs = antibody secreting cells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SC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immunoglobulin secreting cell; NC = no change; NA= not applicable;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↑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increased;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↑↑ = increased 3-4 times or greater; ↓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decreased;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↓↓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decreased 3-4 times or greater; * = statistically significant effect.             = indicates whether the effect was more pronounced in HIFM-transplanted or GF pigs. </a:t>
            </a:r>
            <a:endParaRPr lang="en-US" sz="1000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F6A68F2-1E23-499B-9F47-0E8795397446}"/>
              </a:ext>
            </a:extLst>
          </p:cNvPr>
          <p:cNvSpPr/>
          <p:nvPr/>
        </p:nvSpPr>
        <p:spPr>
          <a:xfrm>
            <a:off x="3213246" y="6542277"/>
            <a:ext cx="335559" cy="12147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45544F60-75F7-4E19-9C7E-C4068B4B51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8637235"/>
              </p:ext>
            </p:extLst>
          </p:nvPr>
        </p:nvGraphicFramePr>
        <p:xfrm>
          <a:off x="521765" y="251884"/>
          <a:ext cx="6328979" cy="575700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737404">
                  <a:extLst>
                    <a:ext uri="{9D8B030D-6E8A-4147-A177-3AD203B41FA5}">
                      <a16:colId xmlns:a16="http://schemas.microsoft.com/office/drawing/2014/main" val="2322537458"/>
                    </a:ext>
                  </a:extLst>
                </a:gridCol>
                <a:gridCol w="1193416">
                  <a:extLst>
                    <a:ext uri="{9D8B030D-6E8A-4147-A177-3AD203B41FA5}">
                      <a16:colId xmlns:a16="http://schemas.microsoft.com/office/drawing/2014/main" val="2883917462"/>
                    </a:ext>
                  </a:extLst>
                </a:gridCol>
                <a:gridCol w="1023457">
                  <a:extLst>
                    <a:ext uri="{9D8B030D-6E8A-4147-A177-3AD203B41FA5}">
                      <a16:colId xmlns:a16="http://schemas.microsoft.com/office/drawing/2014/main" val="3277771571"/>
                    </a:ext>
                  </a:extLst>
                </a:gridCol>
                <a:gridCol w="1216404">
                  <a:extLst>
                    <a:ext uri="{9D8B030D-6E8A-4147-A177-3AD203B41FA5}">
                      <a16:colId xmlns:a16="http://schemas.microsoft.com/office/drawing/2014/main" val="344365464"/>
                    </a:ext>
                  </a:extLst>
                </a:gridCol>
                <a:gridCol w="1158298">
                  <a:extLst>
                    <a:ext uri="{9D8B030D-6E8A-4147-A177-3AD203B41FA5}">
                      <a16:colId xmlns:a16="http://schemas.microsoft.com/office/drawing/2014/main" val="594088730"/>
                    </a:ext>
                  </a:extLst>
                </a:gridCol>
              </a:tblGrid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D0/PCD7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1595953"/>
                  </a:ext>
                </a:extLst>
              </a:tr>
              <a:tr h="32465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ed parameter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 + HIF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f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HIF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2998542652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rrhea severity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/↑↑</a:t>
                      </a: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/↓↓</a:t>
                      </a: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7072144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rus shedding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3479272506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M Ab in ser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↓*</a:t>
                      </a:r>
                      <a:endParaRPr kumimoji="0" lang="en-US" sz="8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↑*</a:t>
                      </a:r>
                      <a:endParaRPr kumimoji="0" lang="en-US" sz="8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↓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↑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2690792110"/>
                  </a:ext>
                </a:extLst>
              </a:tr>
              <a:tr h="18306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G Ab in ser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↓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↑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1505653786"/>
                  </a:ext>
                </a:extLst>
              </a:tr>
              <a:tr h="16685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A Ab in ser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↓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↑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↑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393288552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M Ab in SIC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↑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5827069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G Ab in SIC</a:t>
                      </a:r>
                      <a:endParaRPr lang="en-US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69923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A Ab in SIC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0337064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M Ab in ser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1700573874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G Ab in serum</a:t>
                      </a:r>
                      <a:endParaRPr lang="en-US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8614982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A Ab in ser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*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*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4199151358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M Ab in SIC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3058282166"/>
                  </a:ext>
                </a:extLst>
              </a:tr>
              <a:tr h="1844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G Ab in SIC</a:t>
                      </a:r>
                      <a:endParaRPr lang="en-US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*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3873247751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A Ab in SIC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1538451"/>
                  </a:ext>
                </a:extLst>
              </a:tr>
              <a:tr h="18642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G ASCs in blood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*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*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8679186"/>
                  </a:ext>
                </a:extLst>
              </a:tr>
              <a:tr h="17612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A ASCs in blood</a:t>
                      </a:r>
                      <a:endParaRPr lang="en-US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↓*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↑*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1767825"/>
                  </a:ext>
                </a:extLst>
              </a:tr>
              <a:tr h="2093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M ASCs in duodenum 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5710784"/>
                  </a:ext>
                </a:extLst>
              </a:tr>
              <a:tr h="20394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G ASCs in duodenum</a:t>
                      </a:r>
                      <a:endParaRPr lang="en-US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↓*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↑*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5842783"/>
                  </a:ext>
                </a:extLst>
              </a:tr>
              <a:tr h="2132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A ASCs in duoden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↓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↑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2293251459"/>
                  </a:ext>
                </a:extLst>
              </a:tr>
              <a:tr h="16686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M ASCs in ile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↓*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↑*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28708387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G ASCs in ile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1573736930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specific IgA ASCs in ile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*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*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2199552873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M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lood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3765170740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G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lood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↓*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↑*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4179019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A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lood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7014714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M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duoden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*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*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2948055630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G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duoden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3635356724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A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duoden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extLst>
                  <a:ext uri="{0D108BD9-81ED-4DB2-BD59-A6C34878D82A}">
                    <a16:rowId xmlns:a16="http://schemas.microsoft.com/office/drawing/2014/main" val="3536400151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M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ile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↓*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↑*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479176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G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ile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*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*/↓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086971"/>
                  </a:ext>
                </a:extLst>
              </a:tr>
              <a:tr h="1626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IgA </a:t>
                      </a:r>
                      <a:r>
                        <a:rPr lang="en-U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SCs</a:t>
                      </a: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ileum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↑/↑↑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/↓↓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196" marR="12196" marT="6308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41727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71737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8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42C624AB-178B-4AF7-8515-C78026688C34}">
  <we:reference id="wa104379279" version="2.1.0.0" store="en-US" storeType="OMEX"/>
  <we:alternateReferences>
    <we:reference id="wa104379279" version="2.1.0.0" store="WA104379279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otalTime>573</TotalTime>
  <Words>1699</Words>
  <Application>Microsoft Office PowerPoint</Application>
  <PresentationFormat>Widescreen</PresentationFormat>
  <Paragraphs>471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Ohio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sheem Michael</dc:creator>
  <cp:lastModifiedBy>Michael Johnson</cp:lastModifiedBy>
  <cp:revision>76</cp:revision>
  <cp:lastPrinted>2019-12-26T17:46:39Z</cp:lastPrinted>
  <dcterms:created xsi:type="dcterms:W3CDTF">2019-10-31T20:00:37Z</dcterms:created>
  <dcterms:modified xsi:type="dcterms:W3CDTF">2019-12-27T22:29:24Z</dcterms:modified>
</cp:coreProperties>
</file>